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862F80-0A8D-4E90-BE7E-117201E5CB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9FF34-CC95-404E-BAFA-F3D91A779C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928CB-CFF0-484D-8427-A6C251FBF4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77196-606A-4065-9AFE-BE710D6F9A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E0475-9426-421B-B52E-E2A466B09A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774B2-B63E-490A-BA39-883667B3EF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6E009-EAEE-4D17-A4BA-5D535BA2BC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3169A6-E5D7-47BA-A994-29CCFA2785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C8E67-8871-4EFE-BAC3-8876F23BB3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3FBCF9-FDBC-40E2-B784-6B10F7129D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A91838-860C-461E-927D-892A18BD21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2CC1B3-2F09-4D21-9305-3D9665945F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02A836D-BCAF-4F37-B5B8-4B5338E7102A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6255000" y="63752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8"/>
          <p:cNvGrpSpPr/>
          <p:nvPr/>
        </p:nvGrpSpPr>
        <p:grpSpPr>
          <a:xfrm>
            <a:off x="2050920" y="2162160"/>
            <a:ext cx="5038560" cy="3688560"/>
            <a:chOff x="2050920" y="2162160"/>
            <a:chExt cx="5038560" cy="3688560"/>
          </a:xfrm>
        </p:grpSpPr>
        <p:pic>
          <p:nvPicPr>
            <p:cNvPr id="43" name="Picture 4" descr=""/>
            <p:cNvPicPr/>
            <p:nvPr/>
          </p:nvPicPr>
          <p:blipFill>
            <a:blip r:embed="rId1"/>
            <a:stretch/>
          </p:blipFill>
          <p:spPr>
            <a:xfrm>
              <a:off x="2050920" y="2162160"/>
              <a:ext cx="5038560" cy="2533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Line 5"/>
            <p:cNvSpPr/>
            <p:nvPr/>
          </p:nvSpPr>
          <p:spPr>
            <a:xfrm>
              <a:off x="2626920" y="4581360"/>
              <a:ext cx="3886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6"/>
            <p:cNvSpPr/>
            <p:nvPr/>
          </p:nvSpPr>
          <p:spPr>
            <a:xfrm>
              <a:off x="4003920" y="4673520"/>
              <a:ext cx="85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JamA-P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Group 16"/>
            <p:cNvGrpSpPr/>
            <p:nvPr/>
          </p:nvGrpSpPr>
          <p:grpSpPr>
            <a:xfrm>
              <a:off x="3015000" y="5157720"/>
              <a:ext cx="2428920" cy="693000"/>
              <a:chOff x="3015000" y="5157720"/>
              <a:chExt cx="2428920" cy="693000"/>
            </a:xfrm>
          </p:grpSpPr>
          <p:sp>
            <p:nvSpPr>
              <p:cNvPr id="47" name="Rectangle 10"/>
              <p:cNvSpPr/>
              <p:nvPr/>
            </p:nvSpPr>
            <p:spPr>
              <a:xfrm>
                <a:off x="3015000" y="5216400"/>
                <a:ext cx="582120" cy="144360"/>
              </a:xfrm>
              <a:prstGeom prst="rect">
                <a:avLst/>
              </a:prstGeom>
              <a:solidFill>
                <a:srgbClr val="96969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 Box 11"/>
              <p:cNvSpPr/>
              <p:nvPr/>
            </p:nvSpPr>
            <p:spPr>
              <a:xfrm>
                <a:off x="3535920" y="5157720"/>
                <a:ext cx="16866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100" spc="-1" strike="noStrike">
                    <a:solidFill>
                      <a:srgbClr val="000000"/>
                    </a:solidFill>
                    <a:latin typeface="Arial"/>
                  </a:rPr>
                  <a:t>Mock transfected cell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 Box 12"/>
              <p:cNvSpPr/>
              <p:nvPr/>
            </p:nvSpPr>
            <p:spPr>
              <a:xfrm>
                <a:off x="3554640" y="5589360"/>
                <a:ext cx="15980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100" spc="-1" strike="noStrike">
                    <a:solidFill>
                      <a:srgbClr val="000000"/>
                    </a:solidFill>
                    <a:latin typeface="Arial"/>
                  </a:rPr>
                  <a:t>Isotype control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Text Box 13"/>
              <p:cNvSpPr/>
              <p:nvPr/>
            </p:nvSpPr>
            <p:spPr>
              <a:xfrm>
                <a:off x="3530520" y="5373720"/>
                <a:ext cx="19134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100" spc="-1" strike="noStrike">
                    <a:solidFill>
                      <a:srgbClr val="000000"/>
                    </a:solidFill>
                    <a:latin typeface="Arial"/>
                  </a:rPr>
                  <a:t>siJam-A transfected  cell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14"/>
              <p:cNvSpPr/>
              <p:nvPr/>
            </p:nvSpPr>
            <p:spPr>
              <a:xfrm>
                <a:off x="3016800" y="5734080"/>
                <a:ext cx="582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ctangle 15"/>
              <p:cNvSpPr/>
              <p:nvPr/>
            </p:nvSpPr>
            <p:spPr>
              <a:xfrm>
                <a:off x="3015000" y="5445000"/>
                <a:ext cx="582120" cy="1443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3" name="Text Box 17"/>
          <p:cNvSpPr/>
          <p:nvPr/>
        </p:nvSpPr>
        <p:spPr>
          <a:xfrm>
            <a:off x="470880" y="620640"/>
            <a:ext cx="811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Jam-A expression in MCF7 cells transfected with siRNA targetting Jam-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4T09:28:37Z</dcterms:created>
  <dc:creator>Dr Anne marie IMBERT</dc:creator>
  <dc:description/>
  <dc:language>en-US</dc:language>
  <cp:lastModifiedBy>DSIO</cp:lastModifiedBy>
  <dcterms:modified xsi:type="dcterms:W3CDTF">2012-08-07T08:47:00Z</dcterms:modified>
  <cp:revision>9</cp:revision>
  <dc:subject/>
  <dc:title>Diapositive 1</dc:title>
</cp:coreProperties>
</file>